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charts/chart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howOutlineIcons="0">
    <p:restoredLeft sz="34608"/>
    <p:restoredTop sz="86369"/>
  </p:normalViewPr>
  <p:slideViewPr>
    <p:cSldViewPr snapToGrid="0" snapToObjects="1">
      <p:cViewPr varScale="1">
        <p:scale>
          <a:sx n="117" d="100"/>
          <a:sy n="117" d="100"/>
        </p:scale>
        <p:origin x="712" y="168"/>
      </p:cViewPr>
      <p:guideLst/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Mike/Downloads/figures/county%20estimates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Mike/Downloads/figures/county%20estimates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Mike/Downloads/figures/county%20estimates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Mike/Downloads/figures/county%20estimates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Mike/Downloads/figures/county%20estimates.xlsx" TargetMode="External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Mike/Downloads/figures/county%20estimates.xlsx" TargetMode="External"/><Relationship Id="rId2" Type="http://schemas.microsoft.com/office/2011/relationships/chartColorStyle" Target="colors6.xml"/><Relationship Id="rId1" Type="http://schemas.microsoft.com/office/2011/relationships/chartStyle" Target="style6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layout>
        <c:manualLayout>
          <c:xMode val="edge"/>
          <c:yMode val="edge"/>
          <c:x val="0.4382726452823657"/>
          <c:y val="0.2045081252749833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80" b="1" i="0" u="none" strike="noStrike" kern="1200" spc="0" baseline="0">
              <a:solidFill>
                <a:schemeClr val="tx1"/>
              </a:solidFill>
              <a:latin typeface="Calibri" panose="020F0502020204030204" pitchFamily="34" charset="0"/>
              <a:ea typeface="+mn-ea"/>
              <a:cs typeface="Calibri" panose="020F0502020204030204" pitchFamily="34" charset="0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Sheet 1 - county estimates'!$A$19</c:f>
              <c:strCache>
                <c:ptCount val="1"/>
                <c:pt idx="0">
                  <c:v>Barton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Sheet 1 - county estimates'!$B$63:$J$63</c:f>
                <c:numCache>
                  <c:formatCode>General</c:formatCode>
                  <c:ptCount val="9"/>
                  <c:pt idx="0">
                    <c:v>1.5793389042033701E-2</c:v>
                  </c:pt>
                  <c:pt idx="1">
                    <c:v>9.6647163417548608E-3</c:v>
                  </c:pt>
                  <c:pt idx="2">
                    <c:v>2.1440438558085501E-2</c:v>
                  </c:pt>
                  <c:pt idx="3">
                    <c:v>2.56819012733248E-2</c:v>
                  </c:pt>
                  <c:pt idx="4">
                    <c:v>2.2535975079216099E-2</c:v>
                  </c:pt>
                  <c:pt idx="5">
                    <c:v>1.25404445010596E-2</c:v>
                  </c:pt>
                  <c:pt idx="6">
                    <c:v>4.4080405847734302E-2</c:v>
                  </c:pt>
                  <c:pt idx="7">
                    <c:v>4.4734295670844403E-3</c:v>
                  </c:pt>
                  <c:pt idx="8">
                    <c:v>1.08409988200303E-2</c:v>
                  </c:pt>
                </c:numCache>
              </c:numRef>
            </c:plus>
            <c:minus>
              <c:numRef>
                <c:f>'Sheet 1 - county estimates'!$B$63:$J$63</c:f>
                <c:numCache>
                  <c:formatCode>General</c:formatCode>
                  <c:ptCount val="9"/>
                  <c:pt idx="0">
                    <c:v>1.5793389042033701E-2</c:v>
                  </c:pt>
                  <c:pt idx="1">
                    <c:v>9.6647163417548608E-3</c:v>
                  </c:pt>
                  <c:pt idx="2">
                    <c:v>2.1440438558085501E-2</c:v>
                  </c:pt>
                  <c:pt idx="3">
                    <c:v>2.56819012733248E-2</c:v>
                  </c:pt>
                  <c:pt idx="4">
                    <c:v>2.2535975079216099E-2</c:v>
                  </c:pt>
                  <c:pt idx="5">
                    <c:v>1.25404445010596E-2</c:v>
                  </c:pt>
                  <c:pt idx="6">
                    <c:v>4.4080405847734302E-2</c:v>
                  </c:pt>
                  <c:pt idx="7">
                    <c:v>4.4734295670844403E-3</c:v>
                  </c:pt>
                  <c:pt idx="8">
                    <c:v>1.08409988200303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Sheet 1 - county estimates'!$B$18:$J$18</c:f>
              <c:strCache>
                <c:ptCount val="9"/>
                <c:pt idx="0">
                  <c:v>May </c:v>
                </c:pt>
                <c:pt idx="1">
                  <c:v>June    2014</c:v>
                </c:pt>
                <c:pt idx="2">
                  <c:v>July </c:v>
                </c:pt>
                <c:pt idx="3">
                  <c:v>May </c:v>
                </c:pt>
                <c:pt idx="4">
                  <c:v>June    2015</c:v>
                </c:pt>
                <c:pt idx="5">
                  <c:v>July</c:v>
                </c:pt>
                <c:pt idx="6">
                  <c:v>May</c:v>
                </c:pt>
                <c:pt idx="7">
                  <c:v>June    2016</c:v>
                </c:pt>
                <c:pt idx="8">
                  <c:v>July </c:v>
                </c:pt>
              </c:strCache>
            </c:strRef>
          </c:cat>
          <c:val>
            <c:numRef>
              <c:f>'Sheet 1 - county estimates'!$B$19:$J$19</c:f>
              <c:numCache>
                <c:formatCode>General</c:formatCode>
                <c:ptCount val="9"/>
                <c:pt idx="0">
                  <c:v>0.75627221278345902</c:v>
                </c:pt>
                <c:pt idx="1">
                  <c:v>0.75277991474359096</c:v>
                </c:pt>
                <c:pt idx="2">
                  <c:v>0.80423724241613304</c:v>
                </c:pt>
                <c:pt idx="3">
                  <c:v>0.453542888122897</c:v>
                </c:pt>
                <c:pt idx="4">
                  <c:v>0.355545266767683</c:v>
                </c:pt>
                <c:pt idx="5">
                  <c:v>0.70187259860680995</c:v>
                </c:pt>
                <c:pt idx="6">
                  <c:v>0.70722516609129904</c:v>
                </c:pt>
                <c:pt idx="7">
                  <c:v>0.63062603044700205</c:v>
                </c:pt>
                <c:pt idx="8">
                  <c:v>0.8806583191149169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71BA-C14A-9993-FB421F9B30B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42748320"/>
        <c:axId val="142754552"/>
      </c:barChart>
      <c:catAx>
        <c:axId val="14274832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Calibri" panose="020F0502020204030204" pitchFamily="34" charset="0"/>
                <a:ea typeface="+mn-ea"/>
                <a:cs typeface="Calibri" panose="020F0502020204030204" pitchFamily="34" charset="0"/>
              </a:defRPr>
            </a:pPr>
            <a:endParaRPr lang="en-US"/>
          </a:p>
        </c:txPr>
        <c:crossAx val="142754552"/>
        <c:crosses val="autoZero"/>
        <c:auto val="1"/>
        <c:lblAlgn val="ctr"/>
        <c:lblOffset val="100"/>
        <c:noMultiLvlLbl val="0"/>
      </c:catAx>
      <c:valAx>
        <c:axId val="142754552"/>
        <c:scaling>
          <c:orientation val="minMax"/>
          <c:max val="1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Calibri" panose="020F0502020204030204" pitchFamily="34" charset="0"/>
                <a:ea typeface="+mn-ea"/>
                <a:cs typeface="Calibri" panose="020F0502020204030204" pitchFamily="34" charset="0"/>
              </a:defRPr>
            </a:pPr>
            <a:endParaRPr lang="en-US"/>
          </a:p>
        </c:txPr>
        <c:crossAx val="142748320"/>
        <c:crosses val="autoZero"/>
        <c:crossBetween val="between"/>
        <c:majorUnit val="0.2"/>
      </c:valAx>
      <c:spPr>
        <a:noFill/>
        <a:ln w="25400"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900" b="1">
          <a:latin typeface="Calibri" panose="020F0502020204030204" pitchFamily="34" charset="0"/>
          <a:cs typeface="Calibri" panose="020F0502020204030204" pitchFamily="34" charset="0"/>
        </a:defRPr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layout>
        <c:manualLayout>
          <c:xMode val="edge"/>
          <c:yMode val="edge"/>
          <c:x val="0.48549757521097331"/>
          <c:y val="0.16659978426699373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80" b="1" i="0" u="none" strike="noStrike" kern="1200" spc="0" baseline="0">
              <a:solidFill>
                <a:schemeClr val="tx1"/>
              </a:solidFill>
              <a:latin typeface="Calibri" panose="020F0502020204030204" pitchFamily="34" charset="0"/>
              <a:ea typeface="+mn-ea"/>
              <a:cs typeface="Calibri" panose="020F0502020204030204" pitchFamily="34" charset="0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Sheet 1 - county estimates'!$A$27</c:f>
              <c:strCache>
                <c:ptCount val="1"/>
                <c:pt idx="0">
                  <c:v>Pike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Sheet 1 - county estimates'!$B$67:$J$67</c:f>
                <c:numCache>
                  <c:formatCode>General</c:formatCode>
                  <c:ptCount val="9"/>
                  <c:pt idx="0">
                    <c:v>2.71717722104328E-2</c:v>
                  </c:pt>
                  <c:pt idx="1">
                    <c:v>1.14831022201171E-2</c:v>
                  </c:pt>
                  <c:pt idx="2">
                    <c:v>3.96202515308845E-3</c:v>
                  </c:pt>
                  <c:pt idx="3">
                    <c:v>4.2751868333568303E-2</c:v>
                  </c:pt>
                  <c:pt idx="4">
                    <c:v>4.3697688322707401E-2</c:v>
                  </c:pt>
                  <c:pt idx="5">
                    <c:v>1.6697643876687498E-2</c:v>
                  </c:pt>
                  <c:pt idx="6">
                    <c:v>1.13651217972959E-2</c:v>
                  </c:pt>
                  <c:pt idx="7">
                    <c:v>4.3301664971399497E-3</c:v>
                  </c:pt>
                  <c:pt idx="8">
                    <c:v>2.3279833316035099E-3</c:v>
                  </c:pt>
                </c:numCache>
              </c:numRef>
            </c:plus>
            <c:minus>
              <c:numRef>
                <c:f>'Sheet 1 - county estimates'!$B$67:$J$67</c:f>
                <c:numCache>
                  <c:formatCode>General</c:formatCode>
                  <c:ptCount val="9"/>
                  <c:pt idx="0">
                    <c:v>2.71717722104328E-2</c:v>
                  </c:pt>
                  <c:pt idx="1">
                    <c:v>1.14831022201171E-2</c:v>
                  </c:pt>
                  <c:pt idx="2">
                    <c:v>3.96202515308845E-3</c:v>
                  </c:pt>
                  <c:pt idx="3">
                    <c:v>4.2751868333568303E-2</c:v>
                  </c:pt>
                  <c:pt idx="4">
                    <c:v>4.3697688322707401E-2</c:v>
                  </c:pt>
                  <c:pt idx="5">
                    <c:v>1.6697643876687498E-2</c:v>
                  </c:pt>
                  <c:pt idx="6">
                    <c:v>1.13651217972959E-2</c:v>
                  </c:pt>
                  <c:pt idx="7">
                    <c:v>4.3301664971399497E-3</c:v>
                  </c:pt>
                  <c:pt idx="8">
                    <c:v>2.3279833316035099E-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Sheet 1 - county estimates'!$B$26:$J$26</c:f>
              <c:strCache>
                <c:ptCount val="9"/>
                <c:pt idx="0">
                  <c:v>May </c:v>
                </c:pt>
                <c:pt idx="1">
                  <c:v>June    2014</c:v>
                </c:pt>
                <c:pt idx="2">
                  <c:v>July </c:v>
                </c:pt>
                <c:pt idx="3">
                  <c:v>May </c:v>
                </c:pt>
                <c:pt idx="4">
                  <c:v>June    2015</c:v>
                </c:pt>
                <c:pt idx="5">
                  <c:v>July</c:v>
                </c:pt>
                <c:pt idx="6">
                  <c:v>May</c:v>
                </c:pt>
                <c:pt idx="7">
                  <c:v>June    2016</c:v>
                </c:pt>
                <c:pt idx="8">
                  <c:v>July </c:v>
                </c:pt>
              </c:strCache>
            </c:strRef>
          </c:cat>
          <c:val>
            <c:numRef>
              <c:f>'Sheet 1 - county estimates'!$B$27:$J$27</c:f>
              <c:numCache>
                <c:formatCode>General</c:formatCode>
                <c:ptCount val="9"/>
                <c:pt idx="0">
                  <c:v>0.75543087501695605</c:v>
                </c:pt>
                <c:pt idx="1">
                  <c:v>0.85748171589732802</c:v>
                </c:pt>
                <c:pt idx="2">
                  <c:v>0.93291695038878997</c:v>
                </c:pt>
                <c:pt idx="3">
                  <c:v>0.76296060491138495</c:v>
                </c:pt>
                <c:pt idx="4">
                  <c:v>0.54408900114887104</c:v>
                </c:pt>
                <c:pt idx="5">
                  <c:v>0.54732442831354899</c:v>
                </c:pt>
                <c:pt idx="6">
                  <c:v>0.91598675054066403</c:v>
                </c:pt>
                <c:pt idx="7">
                  <c:v>0.93204600103943303</c:v>
                </c:pt>
                <c:pt idx="8">
                  <c:v>0.9690331392098250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62C4-EC4E-958A-952D3BD908F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42748320"/>
        <c:axId val="142754552"/>
      </c:barChart>
      <c:catAx>
        <c:axId val="14274832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Calibri" panose="020F0502020204030204" pitchFamily="34" charset="0"/>
                <a:ea typeface="+mn-ea"/>
                <a:cs typeface="Calibri" panose="020F0502020204030204" pitchFamily="34" charset="0"/>
              </a:defRPr>
            </a:pPr>
            <a:endParaRPr lang="en-US"/>
          </a:p>
        </c:txPr>
        <c:crossAx val="142754552"/>
        <c:crosses val="autoZero"/>
        <c:auto val="1"/>
        <c:lblAlgn val="ctr"/>
        <c:lblOffset val="100"/>
        <c:noMultiLvlLbl val="0"/>
      </c:catAx>
      <c:valAx>
        <c:axId val="142754552"/>
        <c:scaling>
          <c:orientation val="minMax"/>
          <c:max val="1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Calibri" panose="020F0502020204030204" pitchFamily="34" charset="0"/>
                <a:ea typeface="+mn-ea"/>
                <a:cs typeface="Calibri" panose="020F0502020204030204" pitchFamily="34" charset="0"/>
              </a:defRPr>
            </a:pPr>
            <a:endParaRPr lang="en-US"/>
          </a:p>
        </c:txPr>
        <c:crossAx val="142748320"/>
        <c:crosses val="autoZero"/>
        <c:crossBetween val="between"/>
        <c:majorUnit val="0.2"/>
      </c:valAx>
      <c:spPr>
        <a:noFill/>
        <a:ln w="25400"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900" b="1">
          <a:latin typeface="Calibri" panose="020F0502020204030204" pitchFamily="34" charset="0"/>
          <a:cs typeface="Calibri" panose="020F0502020204030204" pitchFamily="34" charset="0"/>
        </a:defRPr>
      </a:pPr>
      <a:endParaRPr lang="en-U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080" b="1" i="0" u="none" strike="noStrike" kern="1200" spc="0" baseline="0">
                <a:solidFill>
                  <a:schemeClr val="tx1"/>
                </a:solidFill>
                <a:latin typeface="Calibri" panose="020F0502020204030204" pitchFamily="34" charset="0"/>
                <a:ea typeface="+mn-ea"/>
                <a:cs typeface="Calibri" panose="020F0502020204030204" pitchFamily="34" charset="0"/>
              </a:defRPr>
            </a:pPr>
            <a:r>
              <a:rPr lang="en-US" sz="1080" dirty="0">
                <a:solidFill>
                  <a:schemeClr val="tx1"/>
                </a:solidFill>
              </a:rPr>
              <a:t>Pettis</a:t>
            </a:r>
          </a:p>
        </c:rich>
      </c:tx>
      <c:layout>
        <c:manualLayout>
          <c:xMode val="edge"/>
          <c:yMode val="edge"/>
          <c:x val="0.44915737189512117"/>
          <c:y val="0.18694527302253117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80" b="1" i="0" u="none" strike="noStrike" kern="1200" spc="0" baseline="0">
              <a:solidFill>
                <a:schemeClr val="tx1"/>
              </a:solidFill>
              <a:latin typeface="Calibri" panose="020F0502020204030204" pitchFamily="34" charset="0"/>
              <a:ea typeface="+mn-ea"/>
              <a:cs typeface="Calibri" panose="020F0502020204030204" pitchFamily="34" charset="0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Sheet 1 - county estimates'!$A$25</c:f>
              <c:strCache>
                <c:ptCount val="1"/>
                <c:pt idx="0">
                  <c:v>Pettis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Sheet 1 - county estimates'!$B$66:$J$66</c:f>
                <c:numCache>
                  <c:formatCode>General</c:formatCode>
                  <c:ptCount val="9"/>
                  <c:pt idx="0">
                    <c:v>3.0828429822905401E-2</c:v>
                  </c:pt>
                  <c:pt idx="1">
                    <c:v>1.41283236187095E-2</c:v>
                  </c:pt>
                  <c:pt idx="2">
                    <c:v>1.16476926220599E-2</c:v>
                  </c:pt>
                  <c:pt idx="3">
                    <c:v>3.5827034755113799E-2</c:v>
                  </c:pt>
                  <c:pt idx="4">
                    <c:v>2.0351605586405402E-2</c:v>
                  </c:pt>
                  <c:pt idx="5">
                    <c:v>6.2929081645797498E-3</c:v>
                  </c:pt>
                  <c:pt idx="6">
                    <c:v>2.5355311834678498E-2</c:v>
                  </c:pt>
                  <c:pt idx="7">
                    <c:v>9.0227552953131701E-3</c:v>
                  </c:pt>
                  <c:pt idx="8">
                    <c:v>7.3569367201031799E-3</c:v>
                  </c:pt>
                </c:numCache>
              </c:numRef>
            </c:plus>
            <c:minus>
              <c:numRef>
                <c:f>'Sheet 1 - county estimates'!$B$67:$J$67</c:f>
                <c:numCache>
                  <c:formatCode>General</c:formatCode>
                  <c:ptCount val="9"/>
                  <c:pt idx="0">
                    <c:v>2.71717722104328E-2</c:v>
                  </c:pt>
                  <c:pt idx="1">
                    <c:v>1.14831022201171E-2</c:v>
                  </c:pt>
                  <c:pt idx="2">
                    <c:v>3.96202515308845E-3</c:v>
                  </c:pt>
                  <c:pt idx="3">
                    <c:v>4.2751868333568303E-2</c:v>
                  </c:pt>
                  <c:pt idx="4">
                    <c:v>4.3697688322707401E-2</c:v>
                  </c:pt>
                  <c:pt idx="5">
                    <c:v>1.6697643876687498E-2</c:v>
                  </c:pt>
                  <c:pt idx="6">
                    <c:v>1.13651217972959E-2</c:v>
                  </c:pt>
                  <c:pt idx="7">
                    <c:v>4.3301664971399497E-3</c:v>
                  </c:pt>
                  <c:pt idx="8">
                    <c:v>2.3279833316035099E-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Sheet 1 - county estimates'!$B$24:$J$24</c:f>
              <c:strCache>
                <c:ptCount val="9"/>
                <c:pt idx="0">
                  <c:v>May </c:v>
                </c:pt>
                <c:pt idx="1">
                  <c:v>June    2014</c:v>
                </c:pt>
                <c:pt idx="2">
                  <c:v>July </c:v>
                </c:pt>
                <c:pt idx="3">
                  <c:v>May </c:v>
                </c:pt>
                <c:pt idx="4">
                  <c:v>June    2015</c:v>
                </c:pt>
                <c:pt idx="5">
                  <c:v>July</c:v>
                </c:pt>
                <c:pt idx="6">
                  <c:v>May</c:v>
                </c:pt>
                <c:pt idx="7">
                  <c:v>June    2016</c:v>
                </c:pt>
                <c:pt idx="8">
                  <c:v>July </c:v>
                </c:pt>
              </c:strCache>
            </c:strRef>
          </c:cat>
          <c:val>
            <c:numRef>
              <c:f>'Sheet 1 - county estimates'!$B$25:$J$25</c:f>
              <c:numCache>
                <c:formatCode>General</c:formatCode>
                <c:ptCount val="9"/>
                <c:pt idx="0">
                  <c:v>0.60844179359017003</c:v>
                </c:pt>
                <c:pt idx="1">
                  <c:v>0.802063745986896</c:v>
                </c:pt>
                <c:pt idx="2">
                  <c:v>0.84535032557755196</c:v>
                </c:pt>
                <c:pt idx="3">
                  <c:v>0.57305005750723303</c:v>
                </c:pt>
                <c:pt idx="4">
                  <c:v>0.48756067776135897</c:v>
                </c:pt>
                <c:pt idx="5">
                  <c:v>0.65270446892904199</c:v>
                </c:pt>
                <c:pt idx="6">
                  <c:v>0.82844099238376501</c:v>
                </c:pt>
                <c:pt idx="7">
                  <c:v>0.839817683883882</c:v>
                </c:pt>
                <c:pt idx="8">
                  <c:v>0.92380151168196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E2E8-CD42-95F6-4BBF98FB0B2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42748320"/>
        <c:axId val="142754552"/>
      </c:barChart>
      <c:catAx>
        <c:axId val="14274832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Calibri" panose="020F0502020204030204" pitchFamily="34" charset="0"/>
                <a:ea typeface="+mn-ea"/>
                <a:cs typeface="Calibri" panose="020F0502020204030204" pitchFamily="34" charset="0"/>
              </a:defRPr>
            </a:pPr>
            <a:endParaRPr lang="en-US"/>
          </a:p>
        </c:txPr>
        <c:crossAx val="142754552"/>
        <c:crosses val="autoZero"/>
        <c:auto val="1"/>
        <c:lblAlgn val="ctr"/>
        <c:lblOffset val="100"/>
        <c:noMultiLvlLbl val="0"/>
      </c:catAx>
      <c:valAx>
        <c:axId val="142754552"/>
        <c:scaling>
          <c:orientation val="minMax"/>
          <c:max val="1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Calibri" panose="020F0502020204030204" pitchFamily="34" charset="0"/>
                <a:ea typeface="+mn-ea"/>
                <a:cs typeface="Calibri" panose="020F0502020204030204" pitchFamily="34" charset="0"/>
              </a:defRPr>
            </a:pPr>
            <a:endParaRPr lang="en-US"/>
          </a:p>
        </c:txPr>
        <c:crossAx val="142748320"/>
        <c:crosses val="autoZero"/>
        <c:crossBetween val="between"/>
        <c:majorUnit val="0.2"/>
      </c:valAx>
      <c:spPr>
        <a:noFill/>
        <a:ln w="25400"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900" b="1">
          <a:latin typeface="Calibri" panose="020F0502020204030204" pitchFamily="34" charset="0"/>
          <a:cs typeface="Calibri" panose="020F0502020204030204" pitchFamily="34" charset="0"/>
        </a:defRPr>
      </a:pPr>
      <a:endParaRPr lang="en-US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080" b="1" i="0" u="none" strike="noStrike" kern="1200" spc="0" baseline="0">
                <a:solidFill>
                  <a:schemeClr val="tx1"/>
                </a:solidFill>
                <a:latin typeface="Calibri" panose="020F0502020204030204" pitchFamily="34" charset="0"/>
                <a:ea typeface="+mn-ea"/>
                <a:cs typeface="Calibri" panose="020F0502020204030204" pitchFamily="34" charset="0"/>
              </a:defRPr>
            </a:pPr>
            <a:r>
              <a:rPr lang="en-US" sz="1080" dirty="0">
                <a:solidFill>
                  <a:schemeClr val="tx1"/>
                </a:solidFill>
              </a:rPr>
              <a:t>Cape Girardeau</a:t>
            </a:r>
          </a:p>
        </c:rich>
      </c:tx>
      <c:layout>
        <c:manualLayout>
          <c:xMode val="edge"/>
          <c:yMode val="edge"/>
          <c:x val="0.39777272146623477"/>
          <c:y val="0.16659978426699373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80" b="1" i="0" u="none" strike="noStrike" kern="1200" spc="0" baseline="0">
              <a:solidFill>
                <a:schemeClr val="tx1"/>
              </a:solidFill>
              <a:latin typeface="Calibri" panose="020F0502020204030204" pitchFamily="34" charset="0"/>
              <a:ea typeface="+mn-ea"/>
              <a:cs typeface="Calibri" panose="020F0502020204030204" pitchFamily="34" charset="0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Sheet 1 - county estimates'!$A$21</c:f>
              <c:strCache>
                <c:ptCount val="1"/>
                <c:pt idx="0">
                  <c:v>Cape Girardeau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Sheet 1 - county estimates'!$B$64:$J$64</c:f>
                <c:numCache>
                  <c:formatCode>General</c:formatCode>
                  <c:ptCount val="9"/>
                  <c:pt idx="0">
                    <c:v>2.2421791569879699E-2</c:v>
                  </c:pt>
                  <c:pt idx="1">
                    <c:v>5.00030695559389E-3</c:v>
                  </c:pt>
                  <c:pt idx="2">
                    <c:v>3.5314570951763902E-3</c:v>
                  </c:pt>
                  <c:pt idx="3">
                    <c:v>1.7774890506213701E-2</c:v>
                  </c:pt>
                  <c:pt idx="4">
                    <c:v>8.6815877777519299E-3</c:v>
                  </c:pt>
                  <c:pt idx="5">
                    <c:v>4.9235613426877401E-3</c:v>
                  </c:pt>
                  <c:pt idx="6">
                    <c:v>1.6384287751394899E-2</c:v>
                  </c:pt>
                  <c:pt idx="7">
                    <c:v>2.13054014351467E-3</c:v>
                  </c:pt>
                  <c:pt idx="8">
                    <c:v>1.3019694512940801E-3</c:v>
                  </c:pt>
                </c:numCache>
              </c:numRef>
            </c:plus>
            <c:minus>
              <c:numRef>
                <c:f>'Sheet 1 - county estimates'!$B$64:$J$64</c:f>
                <c:numCache>
                  <c:formatCode>General</c:formatCode>
                  <c:ptCount val="9"/>
                  <c:pt idx="0">
                    <c:v>2.2421791569879699E-2</c:v>
                  </c:pt>
                  <c:pt idx="1">
                    <c:v>5.00030695559389E-3</c:v>
                  </c:pt>
                  <c:pt idx="2">
                    <c:v>3.5314570951763902E-3</c:v>
                  </c:pt>
                  <c:pt idx="3">
                    <c:v>1.7774890506213701E-2</c:v>
                  </c:pt>
                  <c:pt idx="4">
                    <c:v>8.6815877777519299E-3</c:v>
                  </c:pt>
                  <c:pt idx="5">
                    <c:v>4.9235613426877401E-3</c:v>
                  </c:pt>
                  <c:pt idx="6">
                    <c:v>1.6384287751394899E-2</c:v>
                  </c:pt>
                  <c:pt idx="7">
                    <c:v>2.13054014351467E-3</c:v>
                  </c:pt>
                  <c:pt idx="8">
                    <c:v>1.3019694512940801E-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Sheet 1 - county estimates'!$B$20:$J$20</c:f>
              <c:strCache>
                <c:ptCount val="9"/>
                <c:pt idx="0">
                  <c:v>May </c:v>
                </c:pt>
                <c:pt idx="1">
                  <c:v>June    2014</c:v>
                </c:pt>
                <c:pt idx="2">
                  <c:v>July </c:v>
                </c:pt>
                <c:pt idx="3">
                  <c:v>May </c:v>
                </c:pt>
                <c:pt idx="4">
                  <c:v>June    2015</c:v>
                </c:pt>
                <c:pt idx="5">
                  <c:v>July</c:v>
                </c:pt>
                <c:pt idx="6">
                  <c:v>May</c:v>
                </c:pt>
                <c:pt idx="7">
                  <c:v>June    2016</c:v>
                </c:pt>
                <c:pt idx="8">
                  <c:v>July </c:v>
                </c:pt>
              </c:strCache>
            </c:strRef>
          </c:cat>
          <c:val>
            <c:numRef>
              <c:f>'Sheet 1 - county estimates'!$B$21:$J$21</c:f>
              <c:numCache>
                <c:formatCode>General</c:formatCode>
                <c:ptCount val="9"/>
                <c:pt idx="0">
                  <c:v>0.67226584429292302</c:v>
                </c:pt>
                <c:pt idx="1">
                  <c:v>0.84345516563662404</c:v>
                </c:pt>
                <c:pt idx="2">
                  <c:v>0.93669167028755995</c:v>
                </c:pt>
                <c:pt idx="3">
                  <c:v>0.72970455872652096</c:v>
                </c:pt>
                <c:pt idx="4">
                  <c:v>0.75253956821623802</c:v>
                </c:pt>
                <c:pt idx="5">
                  <c:v>0.83147427413591102</c:v>
                </c:pt>
                <c:pt idx="6">
                  <c:v>0.85048305443216798</c:v>
                </c:pt>
                <c:pt idx="7">
                  <c:v>0.86855584842078304</c:v>
                </c:pt>
                <c:pt idx="8">
                  <c:v>0.9698399401876359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73ED-104F-AC2C-DBDC20D9979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42748320"/>
        <c:axId val="142754552"/>
      </c:barChart>
      <c:catAx>
        <c:axId val="14274832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Calibri" panose="020F0502020204030204" pitchFamily="34" charset="0"/>
                <a:ea typeface="+mn-ea"/>
                <a:cs typeface="Calibri" panose="020F0502020204030204" pitchFamily="34" charset="0"/>
              </a:defRPr>
            </a:pPr>
            <a:endParaRPr lang="en-US"/>
          </a:p>
        </c:txPr>
        <c:crossAx val="142754552"/>
        <c:crosses val="autoZero"/>
        <c:auto val="1"/>
        <c:lblAlgn val="ctr"/>
        <c:lblOffset val="100"/>
        <c:noMultiLvlLbl val="0"/>
      </c:catAx>
      <c:valAx>
        <c:axId val="142754552"/>
        <c:scaling>
          <c:orientation val="minMax"/>
          <c:max val="1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Calibri" panose="020F0502020204030204" pitchFamily="34" charset="0"/>
                <a:ea typeface="+mn-ea"/>
                <a:cs typeface="Calibri" panose="020F0502020204030204" pitchFamily="34" charset="0"/>
              </a:defRPr>
            </a:pPr>
            <a:endParaRPr lang="en-US"/>
          </a:p>
        </c:txPr>
        <c:crossAx val="142748320"/>
        <c:crosses val="autoZero"/>
        <c:crossBetween val="between"/>
        <c:majorUnit val="0.2"/>
      </c:valAx>
      <c:spPr>
        <a:noFill/>
        <a:ln w="25400"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900" b="1">
          <a:latin typeface="Calibri" panose="020F0502020204030204" pitchFamily="34" charset="0"/>
          <a:cs typeface="Calibri" panose="020F0502020204030204" pitchFamily="34" charset="0"/>
        </a:defRPr>
      </a:pPr>
      <a:endParaRPr lang="en-US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layout>
        <c:manualLayout>
          <c:xMode val="edge"/>
          <c:yMode val="edge"/>
          <c:x val="0.43696004032711117"/>
          <c:y val="0.14396337026673686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80" b="1" i="0" u="none" strike="noStrike" kern="1200" spc="0" baseline="0">
              <a:solidFill>
                <a:schemeClr val="tx1"/>
              </a:solidFill>
              <a:latin typeface="Calibri" panose="020F0502020204030204" pitchFamily="34" charset="0"/>
              <a:ea typeface="+mn-ea"/>
              <a:cs typeface="Calibri" panose="020F0502020204030204" pitchFamily="34" charset="0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Sheet 1 - county estimates'!$A$23</c:f>
              <c:strCache>
                <c:ptCount val="1"/>
                <c:pt idx="0">
                  <c:v>Cooper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Sheet 1 - county estimates'!$B$65:$J$65</c:f>
                <c:numCache>
                  <c:formatCode>General</c:formatCode>
                  <c:ptCount val="9"/>
                  <c:pt idx="0">
                    <c:v>2.4536466808137598E-2</c:v>
                  </c:pt>
                  <c:pt idx="1">
                    <c:v>9.5084132609182404E-3</c:v>
                  </c:pt>
                  <c:pt idx="2">
                    <c:v>6.0188392270087102E-3</c:v>
                  </c:pt>
                  <c:pt idx="3">
                    <c:v>3.2640780029214798E-2</c:v>
                  </c:pt>
                  <c:pt idx="4">
                    <c:v>2.194841292277E-2</c:v>
                  </c:pt>
                  <c:pt idx="5">
                    <c:v>6.7394712548709797E-3</c:v>
                  </c:pt>
                  <c:pt idx="6">
                    <c:v>1.6160146922606901E-2</c:v>
                  </c:pt>
                  <c:pt idx="7">
                    <c:v>6.8309717052779297E-3</c:v>
                  </c:pt>
                  <c:pt idx="8">
                    <c:v>7.5983248445327198E-3</c:v>
                  </c:pt>
                </c:numCache>
              </c:numRef>
            </c:plus>
            <c:minus>
              <c:numRef>
                <c:f>'Sheet 1 - county estimates'!$B$65:$J$65</c:f>
                <c:numCache>
                  <c:formatCode>General</c:formatCode>
                  <c:ptCount val="9"/>
                  <c:pt idx="0">
                    <c:v>2.4536466808137598E-2</c:v>
                  </c:pt>
                  <c:pt idx="1">
                    <c:v>9.5084132609182404E-3</c:v>
                  </c:pt>
                  <c:pt idx="2">
                    <c:v>6.0188392270087102E-3</c:v>
                  </c:pt>
                  <c:pt idx="3">
                    <c:v>3.2640780029214798E-2</c:v>
                  </c:pt>
                  <c:pt idx="4">
                    <c:v>2.194841292277E-2</c:v>
                  </c:pt>
                  <c:pt idx="5">
                    <c:v>6.7394712548709797E-3</c:v>
                  </c:pt>
                  <c:pt idx="6">
                    <c:v>1.6160146922606901E-2</c:v>
                  </c:pt>
                  <c:pt idx="7">
                    <c:v>6.8309717052779297E-3</c:v>
                  </c:pt>
                  <c:pt idx="8">
                    <c:v>7.5983248445327198E-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Sheet 1 - county estimates'!$B$22:$J$22</c:f>
              <c:strCache>
                <c:ptCount val="9"/>
                <c:pt idx="0">
                  <c:v>May </c:v>
                </c:pt>
                <c:pt idx="1">
                  <c:v>June    2014</c:v>
                </c:pt>
                <c:pt idx="2">
                  <c:v>July </c:v>
                </c:pt>
                <c:pt idx="3">
                  <c:v>May </c:v>
                </c:pt>
                <c:pt idx="4">
                  <c:v>June    2015</c:v>
                </c:pt>
                <c:pt idx="5">
                  <c:v>July</c:v>
                </c:pt>
                <c:pt idx="6">
                  <c:v>May</c:v>
                </c:pt>
                <c:pt idx="7">
                  <c:v>June    2016</c:v>
                </c:pt>
                <c:pt idx="8">
                  <c:v>July </c:v>
                </c:pt>
              </c:strCache>
            </c:strRef>
          </c:cat>
          <c:val>
            <c:numRef>
              <c:f>'Sheet 1 - county estimates'!$B$23:$J$23</c:f>
              <c:numCache>
                <c:formatCode>General</c:formatCode>
                <c:ptCount val="9"/>
                <c:pt idx="0">
                  <c:v>0.70620599877580303</c:v>
                </c:pt>
                <c:pt idx="1">
                  <c:v>0.86822607164268395</c:v>
                </c:pt>
                <c:pt idx="2">
                  <c:v>0.89971411036318305</c:v>
                </c:pt>
                <c:pt idx="3">
                  <c:v>0.71687850923039498</c:v>
                </c:pt>
                <c:pt idx="4">
                  <c:v>0.65330822334618199</c:v>
                </c:pt>
                <c:pt idx="5">
                  <c:v>0.723998531793833</c:v>
                </c:pt>
                <c:pt idx="6">
                  <c:v>0.87386666403638302</c:v>
                </c:pt>
                <c:pt idx="7">
                  <c:v>0.89547692934875001</c:v>
                </c:pt>
                <c:pt idx="8">
                  <c:v>0.9281354093761230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D8F6-6E45-B609-5C9B8AF1978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42748320"/>
        <c:axId val="142754552"/>
      </c:barChart>
      <c:catAx>
        <c:axId val="14274832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Calibri" panose="020F0502020204030204" pitchFamily="34" charset="0"/>
                <a:ea typeface="+mn-ea"/>
                <a:cs typeface="Calibri" panose="020F0502020204030204" pitchFamily="34" charset="0"/>
              </a:defRPr>
            </a:pPr>
            <a:endParaRPr lang="en-US"/>
          </a:p>
        </c:txPr>
        <c:crossAx val="142754552"/>
        <c:crosses val="autoZero"/>
        <c:auto val="1"/>
        <c:lblAlgn val="ctr"/>
        <c:lblOffset val="100"/>
        <c:noMultiLvlLbl val="0"/>
      </c:catAx>
      <c:valAx>
        <c:axId val="142754552"/>
        <c:scaling>
          <c:orientation val="minMax"/>
          <c:max val="1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Calibri" panose="020F0502020204030204" pitchFamily="34" charset="0"/>
                <a:ea typeface="+mn-ea"/>
                <a:cs typeface="Calibri" panose="020F0502020204030204" pitchFamily="34" charset="0"/>
              </a:defRPr>
            </a:pPr>
            <a:endParaRPr lang="en-US"/>
          </a:p>
        </c:txPr>
        <c:crossAx val="142748320"/>
        <c:crosses val="autoZero"/>
        <c:crossBetween val="between"/>
        <c:majorUnit val="0.2"/>
      </c:valAx>
      <c:spPr>
        <a:noFill/>
        <a:ln w="25400"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900" b="1">
          <a:latin typeface="Calibri" panose="020F0502020204030204" pitchFamily="34" charset="0"/>
          <a:cs typeface="Calibri" panose="020F0502020204030204" pitchFamily="34" charset="0"/>
        </a:defRPr>
      </a:pPr>
      <a:endParaRPr lang="en-US"/>
    </a:p>
  </c:txPr>
  <c:externalData r:id="rId3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layout>
        <c:manualLayout>
          <c:xMode val="edge"/>
          <c:yMode val="edge"/>
          <c:x val="0.420923839051908"/>
          <c:y val="0.2103606774607644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80" b="1" i="0" u="none" strike="noStrike" kern="1200" spc="0" baseline="0">
              <a:solidFill>
                <a:schemeClr val="tx1"/>
              </a:solidFill>
              <a:latin typeface="Calibri" panose="020F0502020204030204" pitchFamily="34" charset="0"/>
              <a:ea typeface="+mn-ea"/>
              <a:cs typeface="Calibri" panose="020F0502020204030204" pitchFamily="34" charset="0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Sheet 1 - county estimates'!$A$29</c:f>
              <c:strCache>
                <c:ptCount val="1"/>
                <c:pt idx="0">
                  <c:v>Stoddard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Sheet 1 - county estimates'!$B$68:$J$68</c:f>
                <c:numCache>
                  <c:formatCode>General</c:formatCode>
                  <c:ptCount val="9"/>
                  <c:pt idx="0">
                    <c:v>1.9065407379206398E-2</c:v>
                  </c:pt>
                  <c:pt idx="1">
                    <c:v>1.84934053647237E-2</c:v>
                  </c:pt>
                  <c:pt idx="2">
                    <c:v>4.6398291340628797E-2</c:v>
                  </c:pt>
                  <c:pt idx="3">
                    <c:v>1.5649394838365499E-2</c:v>
                  </c:pt>
                  <c:pt idx="4">
                    <c:v>2.0115093345747501E-2</c:v>
                  </c:pt>
                  <c:pt idx="5">
                    <c:v>2.1372558276382899E-2</c:v>
                  </c:pt>
                  <c:pt idx="6">
                    <c:v>6.5267587873471297E-2</c:v>
                  </c:pt>
                  <c:pt idx="7">
                    <c:v>1.6945696190172201E-2</c:v>
                  </c:pt>
                  <c:pt idx="8">
                    <c:v>2.9870121649833499E-2</c:v>
                  </c:pt>
                </c:numCache>
              </c:numRef>
            </c:plus>
            <c:minus>
              <c:numRef>
                <c:f>'Sheet 1 - county estimates'!$B$68:$J$68</c:f>
                <c:numCache>
                  <c:formatCode>General</c:formatCode>
                  <c:ptCount val="9"/>
                  <c:pt idx="0">
                    <c:v>1.9065407379206398E-2</c:v>
                  </c:pt>
                  <c:pt idx="1">
                    <c:v>1.84934053647237E-2</c:v>
                  </c:pt>
                  <c:pt idx="2">
                    <c:v>4.6398291340628797E-2</c:v>
                  </c:pt>
                  <c:pt idx="3">
                    <c:v>1.5649394838365499E-2</c:v>
                  </c:pt>
                  <c:pt idx="4">
                    <c:v>2.0115093345747501E-2</c:v>
                  </c:pt>
                  <c:pt idx="5">
                    <c:v>2.1372558276382899E-2</c:v>
                  </c:pt>
                  <c:pt idx="6">
                    <c:v>6.5267587873471297E-2</c:v>
                  </c:pt>
                  <c:pt idx="7">
                    <c:v>1.6945696190172201E-2</c:v>
                  </c:pt>
                  <c:pt idx="8">
                    <c:v>2.9870121649833499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Sheet 1 - county estimates'!$B$28:$J$28</c:f>
              <c:strCache>
                <c:ptCount val="9"/>
                <c:pt idx="0">
                  <c:v>May </c:v>
                </c:pt>
                <c:pt idx="1">
                  <c:v>June    2014</c:v>
                </c:pt>
                <c:pt idx="2">
                  <c:v>July </c:v>
                </c:pt>
                <c:pt idx="3">
                  <c:v>May </c:v>
                </c:pt>
                <c:pt idx="4">
                  <c:v>June    2015</c:v>
                </c:pt>
                <c:pt idx="5">
                  <c:v>July</c:v>
                </c:pt>
                <c:pt idx="6">
                  <c:v>May</c:v>
                </c:pt>
                <c:pt idx="7">
                  <c:v>June    2016</c:v>
                </c:pt>
                <c:pt idx="8">
                  <c:v>July </c:v>
                </c:pt>
              </c:strCache>
            </c:strRef>
          </c:cat>
          <c:val>
            <c:numRef>
              <c:f>'Sheet 1 - county estimates'!$B$29:$J$29</c:f>
              <c:numCache>
                <c:formatCode>General</c:formatCode>
                <c:ptCount val="9"/>
                <c:pt idx="0">
                  <c:v>0.20382120733867601</c:v>
                </c:pt>
                <c:pt idx="1">
                  <c:v>0.41306070762417701</c:v>
                </c:pt>
                <c:pt idx="2">
                  <c:v>0.61791161807007999</c:v>
                </c:pt>
                <c:pt idx="3">
                  <c:v>0.21011283664305</c:v>
                </c:pt>
                <c:pt idx="4">
                  <c:v>0.34004981653395799</c:v>
                </c:pt>
                <c:pt idx="5">
                  <c:v>0.44196571901886</c:v>
                </c:pt>
                <c:pt idx="6">
                  <c:v>0.418191507658563</c:v>
                </c:pt>
                <c:pt idx="7">
                  <c:v>0.46546971326960501</c:v>
                </c:pt>
                <c:pt idx="8">
                  <c:v>0.8153262096324419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4BBF-F140-8BE7-80170FF1F9B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42748320"/>
        <c:axId val="142754552"/>
      </c:barChart>
      <c:catAx>
        <c:axId val="14274832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Calibri" panose="020F0502020204030204" pitchFamily="34" charset="0"/>
                <a:ea typeface="+mn-ea"/>
                <a:cs typeface="Calibri" panose="020F0502020204030204" pitchFamily="34" charset="0"/>
              </a:defRPr>
            </a:pPr>
            <a:endParaRPr lang="en-US"/>
          </a:p>
        </c:txPr>
        <c:crossAx val="142754552"/>
        <c:crosses val="autoZero"/>
        <c:auto val="1"/>
        <c:lblAlgn val="ctr"/>
        <c:lblOffset val="100"/>
        <c:noMultiLvlLbl val="0"/>
      </c:catAx>
      <c:valAx>
        <c:axId val="142754552"/>
        <c:scaling>
          <c:orientation val="minMax"/>
          <c:max val="1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Calibri" panose="020F0502020204030204" pitchFamily="34" charset="0"/>
                <a:ea typeface="+mn-ea"/>
                <a:cs typeface="Calibri" panose="020F0502020204030204" pitchFamily="34" charset="0"/>
              </a:defRPr>
            </a:pPr>
            <a:endParaRPr lang="en-US"/>
          </a:p>
        </c:txPr>
        <c:crossAx val="142748320"/>
        <c:crosses val="autoZero"/>
        <c:crossBetween val="between"/>
        <c:majorUnit val="0.2"/>
      </c:valAx>
      <c:spPr>
        <a:noFill/>
        <a:ln w="25400"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900" b="1">
          <a:latin typeface="Calibri" panose="020F0502020204030204" pitchFamily="34" charset="0"/>
          <a:cs typeface="Calibri" panose="020F0502020204030204" pitchFamily="34" charset="0"/>
        </a:defRPr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79CDA6-E715-964B-A9C5-6A0BEAF3563E}" type="datetimeFigureOut">
              <a:rPr lang="en-US" smtClean="0"/>
              <a:t>4/10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8CAF49-9498-5F49-A338-394AF119A3F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2247352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79CDA6-E715-964B-A9C5-6A0BEAF3563E}" type="datetimeFigureOut">
              <a:rPr lang="en-US" smtClean="0"/>
              <a:t>4/10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8CAF49-9498-5F49-A338-394AF119A3F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0634025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79CDA6-E715-964B-A9C5-6A0BEAF3563E}" type="datetimeFigureOut">
              <a:rPr lang="en-US" smtClean="0"/>
              <a:t>4/10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8CAF49-9498-5F49-A338-394AF119A3F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628062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79CDA6-E715-964B-A9C5-6A0BEAF3563E}" type="datetimeFigureOut">
              <a:rPr lang="en-US" smtClean="0"/>
              <a:t>4/10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8CAF49-9498-5F49-A338-394AF119A3F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185394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79CDA6-E715-964B-A9C5-6A0BEAF3563E}" type="datetimeFigureOut">
              <a:rPr lang="en-US" smtClean="0"/>
              <a:t>4/10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8CAF49-9498-5F49-A338-394AF119A3F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8207177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79CDA6-E715-964B-A9C5-6A0BEAF3563E}" type="datetimeFigureOut">
              <a:rPr lang="en-US" smtClean="0"/>
              <a:t>4/10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8CAF49-9498-5F49-A338-394AF119A3F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4932230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79CDA6-E715-964B-A9C5-6A0BEAF3563E}" type="datetimeFigureOut">
              <a:rPr lang="en-US" smtClean="0"/>
              <a:t>4/10/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8CAF49-9498-5F49-A338-394AF119A3F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9512871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79CDA6-E715-964B-A9C5-6A0BEAF3563E}" type="datetimeFigureOut">
              <a:rPr lang="en-US" smtClean="0"/>
              <a:t>4/10/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8CAF49-9498-5F49-A338-394AF119A3F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550262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79CDA6-E715-964B-A9C5-6A0BEAF3563E}" type="datetimeFigureOut">
              <a:rPr lang="en-US" smtClean="0"/>
              <a:t>4/10/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8CAF49-9498-5F49-A338-394AF119A3F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6191130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79CDA6-E715-964B-A9C5-6A0BEAF3563E}" type="datetimeFigureOut">
              <a:rPr lang="en-US" smtClean="0"/>
              <a:t>4/10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8CAF49-9498-5F49-A338-394AF119A3F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1548459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79CDA6-E715-964B-A9C5-6A0BEAF3563E}" type="datetimeFigureOut">
              <a:rPr lang="en-US" smtClean="0"/>
              <a:t>4/10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8CAF49-9498-5F49-A338-394AF119A3F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6490181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679CDA6-E715-964B-A9C5-6A0BEAF3563E}" type="datetimeFigureOut">
              <a:rPr lang="en-US" smtClean="0"/>
              <a:t>4/10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28CAF49-9498-5F49-A338-394AF119A3F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475046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7" Type="http://schemas.openxmlformats.org/officeDocument/2006/relationships/chart" Target="../charts/chart6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Relationship Id="rId6" Type="http://schemas.openxmlformats.org/officeDocument/2006/relationships/chart" Target="../charts/chart5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2" name="Group 21">
            <a:extLst>
              <a:ext uri="{FF2B5EF4-FFF2-40B4-BE49-F238E27FC236}">
                <a16:creationId xmlns:a16="http://schemas.microsoft.com/office/drawing/2014/main" id="{AA601942-9D1D-5748-9A27-A04B7BE3EE8D}"/>
              </a:ext>
            </a:extLst>
          </p:cNvPr>
          <p:cNvGrpSpPr/>
          <p:nvPr/>
        </p:nvGrpSpPr>
        <p:grpSpPr>
          <a:xfrm>
            <a:off x="475488" y="476704"/>
            <a:ext cx="8324887" cy="6062724"/>
            <a:chOff x="475488" y="476704"/>
            <a:chExt cx="8324887" cy="6062724"/>
          </a:xfrm>
        </p:grpSpPr>
        <p:sp>
          <p:nvSpPr>
            <p:cNvPr id="4" name="Rectangle 3">
              <a:extLst>
                <a:ext uri="{FF2B5EF4-FFF2-40B4-BE49-F238E27FC236}">
                  <a16:creationId xmlns:a16="http://schemas.microsoft.com/office/drawing/2014/main" id="{431A82D1-6D44-E040-A7EB-B4488BB8DCB1}"/>
                </a:ext>
              </a:extLst>
            </p:cNvPr>
            <p:cNvSpPr/>
            <p:nvPr/>
          </p:nvSpPr>
          <p:spPr>
            <a:xfrm>
              <a:off x="667185" y="6077763"/>
              <a:ext cx="8133190" cy="461665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just">
                <a:tabLst>
                  <a:tab pos="228600" algn="l"/>
                </a:tabLst>
              </a:pPr>
              <a:r>
                <a:rPr lang="en-US" sz="1200" dirty="0">
                  <a:latin typeface="Calibri" panose="020F0502020204030204" pitchFamily="34" charset="0"/>
                  <a:ea typeface="Times New Roman" panose="02020603050405020304" pitchFamily="18" charset="0"/>
                  <a:cs typeface="Calibri" panose="020F0502020204030204" pitchFamily="34" charset="0"/>
                </a:rPr>
                <a:t>S1 Figure. Probability of </a:t>
              </a:r>
              <a:r>
                <a:rPr lang="en-US" sz="1200" i="1" dirty="0">
                  <a:latin typeface="Calibri" panose="020F0502020204030204" pitchFamily="34" charset="0"/>
                  <a:ea typeface="Times New Roman" panose="02020603050405020304" pitchFamily="18" charset="0"/>
                  <a:cs typeface="Calibri" panose="020F0502020204030204" pitchFamily="34" charset="0"/>
                </a:rPr>
                <a:t>A. </a:t>
              </a:r>
              <a:r>
                <a:rPr lang="en-US" sz="1200" i="1" dirty="0" err="1">
                  <a:latin typeface="Calibri" panose="020F0502020204030204" pitchFamily="34" charset="0"/>
                  <a:ea typeface="Times New Roman" panose="02020603050405020304" pitchFamily="18" charset="0"/>
                  <a:cs typeface="Calibri" panose="020F0502020204030204" pitchFamily="34" charset="0"/>
                </a:rPr>
                <a:t>tosichella</a:t>
              </a:r>
              <a:r>
                <a:rPr lang="en-US" sz="1200" dirty="0">
                  <a:latin typeface="Calibri" panose="020F0502020204030204" pitchFamily="34" charset="0"/>
                  <a:ea typeface="Times New Roman" panose="02020603050405020304" pitchFamily="18" charset="0"/>
                  <a:cs typeface="Calibri" panose="020F0502020204030204" pitchFamily="34" charset="0"/>
                </a:rPr>
                <a:t> biotype 1 occurrence (mean </a:t>
              </a:r>
              <a:r>
                <a:rPr lang="en-US" sz="1200" dirty="0">
                  <a:solidFill>
                    <a:srgbClr val="000000"/>
                  </a:solidFill>
                  <a:latin typeface="Calibri" panose="020F0502020204030204" pitchFamily="34" charset="0"/>
                  <a:ea typeface="Times New Roman" panose="02020603050405020304" pitchFamily="18" charset="0"/>
                  <a:cs typeface="Calibri" panose="020F0502020204030204" pitchFamily="34" charset="0"/>
                </a:rPr>
                <a:t>± SE</a:t>
              </a:r>
              <a:r>
                <a:rPr lang="en-US" sz="1200" dirty="0">
                  <a:latin typeface="Calibri" panose="020F0502020204030204" pitchFamily="34" charset="0"/>
                  <a:ea typeface="Times New Roman" panose="02020603050405020304" pitchFamily="18" charset="0"/>
                  <a:cs typeface="Calibri" panose="020F0502020204030204" pitchFamily="34" charset="0"/>
                </a:rPr>
                <a:t>) at locations in Barton (A), Pettis (B), </a:t>
              </a:r>
              <a:r>
                <a:rPr lang="en-US" sz="1200" dirty="0"/>
                <a:t>Cape Girardeau </a:t>
              </a:r>
              <a:r>
                <a:rPr lang="en-US" sz="1200" dirty="0">
                  <a:latin typeface="Calibri" panose="020F0502020204030204" pitchFamily="34" charset="0"/>
                  <a:ea typeface="Times New Roman" panose="02020603050405020304" pitchFamily="18" charset="0"/>
                  <a:cs typeface="Calibri" panose="020F0502020204030204" pitchFamily="34" charset="0"/>
                </a:rPr>
                <a:t>(C), Pike (D), Copper (E) and Stoddard (F) </a:t>
              </a:r>
              <a:r>
                <a:rPr lang="en-US" sz="1200">
                  <a:latin typeface="Calibri" panose="020F0502020204030204" pitchFamily="34" charset="0"/>
                  <a:ea typeface="Times New Roman" panose="02020603050405020304" pitchFamily="18" charset="0"/>
                  <a:cs typeface="Calibri" panose="020F0502020204030204" pitchFamily="34" charset="0"/>
                </a:rPr>
                <a:t>county Missouri </a:t>
              </a:r>
              <a:r>
                <a:rPr lang="en-US" sz="1200" dirty="0">
                  <a:latin typeface="Calibri" panose="020F0502020204030204" pitchFamily="34" charset="0"/>
                  <a:ea typeface="Times New Roman" panose="02020603050405020304" pitchFamily="18" charset="0"/>
                  <a:cs typeface="Calibri" panose="020F0502020204030204" pitchFamily="34" charset="0"/>
                </a:rPr>
                <a:t>in 2014, 2015 and 2016.</a:t>
              </a:r>
              <a:endParaRPr lang="en-US" sz="1400" dirty="0"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21" name="Group 20">
              <a:extLst>
                <a:ext uri="{FF2B5EF4-FFF2-40B4-BE49-F238E27FC236}">
                  <a16:creationId xmlns:a16="http://schemas.microsoft.com/office/drawing/2014/main" id="{6A5B0B37-1A3C-5643-87BC-42FDB85F3C96}"/>
                </a:ext>
              </a:extLst>
            </p:cNvPr>
            <p:cNvGrpSpPr/>
            <p:nvPr/>
          </p:nvGrpSpPr>
          <p:grpSpPr>
            <a:xfrm>
              <a:off x="475488" y="476704"/>
              <a:ext cx="8324887" cy="5592156"/>
              <a:chOff x="292608" y="476704"/>
              <a:chExt cx="8324887" cy="5592156"/>
            </a:xfrm>
          </p:grpSpPr>
          <p:grpSp>
            <p:nvGrpSpPr>
              <p:cNvPr id="5" name="Group 4">
                <a:extLst>
                  <a:ext uri="{FF2B5EF4-FFF2-40B4-BE49-F238E27FC236}">
                    <a16:creationId xmlns:a16="http://schemas.microsoft.com/office/drawing/2014/main" id="{5AE51D1A-46E1-46ED-B465-FE41C1DA1FFB}"/>
                  </a:ext>
                </a:extLst>
              </p:cNvPr>
              <p:cNvGrpSpPr/>
              <p:nvPr/>
            </p:nvGrpSpPr>
            <p:grpSpPr>
              <a:xfrm>
                <a:off x="621302" y="476704"/>
                <a:ext cx="7996193" cy="5233273"/>
                <a:chOff x="-177672" y="-294267"/>
                <a:chExt cx="13645341" cy="8982371"/>
              </a:xfrm>
            </p:grpSpPr>
            <p:graphicFrame>
              <p:nvGraphicFramePr>
                <p:cNvPr id="6" name="Chart 5">
                  <a:extLst>
                    <a:ext uri="{FF2B5EF4-FFF2-40B4-BE49-F238E27FC236}">
                      <a16:creationId xmlns:a16="http://schemas.microsoft.com/office/drawing/2014/main" id="{A8FAE0CF-1E2B-498A-83DE-20AD4E3C64E7}"/>
                    </a:ext>
                  </a:extLst>
                </p:cNvPr>
                <p:cNvGraphicFramePr/>
                <p:nvPr>
                  <p:extLst>
                    <p:ext uri="{D42A27DB-BD31-4B8C-83A1-F6EECF244321}">
                      <p14:modId xmlns:p14="http://schemas.microsoft.com/office/powerpoint/2010/main" val="1397094134"/>
                    </p:ext>
                  </p:extLst>
                </p:nvPr>
              </p:nvGraphicFramePr>
              <p:xfrm>
                <a:off x="-177672" y="-262779"/>
                <a:ext cx="6746149" cy="2894644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2"/>
                </a:graphicData>
              </a:graphic>
            </p:graphicFrame>
            <p:graphicFrame>
              <p:nvGraphicFramePr>
                <p:cNvPr id="7" name="Chart 6">
                  <a:extLst>
                    <a:ext uri="{FF2B5EF4-FFF2-40B4-BE49-F238E27FC236}">
                      <a16:creationId xmlns:a16="http://schemas.microsoft.com/office/drawing/2014/main" id="{6AE9A368-5656-42EC-BE86-526D58766605}"/>
                    </a:ext>
                  </a:extLst>
                </p:cNvPr>
                <p:cNvGraphicFramePr>
                  <a:graphicFrameLocks/>
                </p:cNvGraphicFramePr>
                <p:nvPr>
                  <p:extLst>
                    <p:ext uri="{D42A27DB-BD31-4B8C-83A1-F6EECF244321}">
                      <p14:modId xmlns:p14="http://schemas.microsoft.com/office/powerpoint/2010/main" val="3644291448"/>
                    </p:ext>
                  </p:extLst>
                </p:nvPr>
              </p:nvGraphicFramePr>
              <p:xfrm>
                <a:off x="6693374" y="2893461"/>
                <a:ext cx="6746149" cy="2878521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3"/>
                </a:graphicData>
              </a:graphic>
            </p:graphicFrame>
            <p:graphicFrame>
              <p:nvGraphicFramePr>
                <p:cNvPr id="8" name="Chart 7">
                  <a:extLst>
                    <a:ext uri="{FF2B5EF4-FFF2-40B4-BE49-F238E27FC236}">
                      <a16:creationId xmlns:a16="http://schemas.microsoft.com/office/drawing/2014/main" id="{0BF61FE4-952B-4FCB-8004-B20DC9132421}"/>
                    </a:ext>
                  </a:extLst>
                </p:cNvPr>
                <p:cNvGraphicFramePr>
                  <a:graphicFrameLocks/>
                </p:cNvGraphicFramePr>
                <p:nvPr>
                  <p:extLst>
                    <p:ext uri="{D42A27DB-BD31-4B8C-83A1-F6EECF244321}">
                      <p14:modId xmlns:p14="http://schemas.microsoft.com/office/powerpoint/2010/main" val="248289311"/>
                    </p:ext>
                  </p:extLst>
                </p:nvPr>
              </p:nvGraphicFramePr>
              <p:xfrm>
                <a:off x="6721520" y="-294267"/>
                <a:ext cx="6746149" cy="2915055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4"/>
                </a:graphicData>
              </a:graphic>
            </p:graphicFrame>
            <p:graphicFrame>
              <p:nvGraphicFramePr>
                <p:cNvPr id="9" name="Chart 8">
                  <a:extLst>
                    <a:ext uri="{FF2B5EF4-FFF2-40B4-BE49-F238E27FC236}">
                      <a16:creationId xmlns:a16="http://schemas.microsoft.com/office/drawing/2014/main" id="{F92508D9-C1D4-4878-9C1E-7C8F8505094D}"/>
                    </a:ext>
                  </a:extLst>
                </p:cNvPr>
                <p:cNvGraphicFramePr>
                  <a:graphicFrameLocks/>
                </p:cNvGraphicFramePr>
                <p:nvPr>
                  <p:extLst>
                    <p:ext uri="{D42A27DB-BD31-4B8C-83A1-F6EECF244321}">
                      <p14:modId xmlns:p14="http://schemas.microsoft.com/office/powerpoint/2010/main" val="3931365251"/>
                    </p:ext>
                  </p:extLst>
                </p:nvPr>
              </p:nvGraphicFramePr>
              <p:xfrm>
                <a:off x="0" y="2918617"/>
                <a:ext cx="6746149" cy="2878521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5"/>
                </a:graphicData>
              </a:graphic>
            </p:graphicFrame>
            <p:graphicFrame>
              <p:nvGraphicFramePr>
                <p:cNvPr id="10" name="Chart 9">
                  <a:extLst>
                    <a:ext uri="{FF2B5EF4-FFF2-40B4-BE49-F238E27FC236}">
                      <a16:creationId xmlns:a16="http://schemas.microsoft.com/office/drawing/2014/main" id="{5F311BA6-4A21-4B22-A192-CA0C6F74D286}"/>
                    </a:ext>
                  </a:extLst>
                </p:cNvPr>
                <p:cNvGraphicFramePr>
                  <a:graphicFrameLocks/>
                </p:cNvGraphicFramePr>
                <p:nvPr>
                  <p:extLst>
                    <p:ext uri="{D42A27DB-BD31-4B8C-83A1-F6EECF244321}">
                      <p14:modId xmlns:p14="http://schemas.microsoft.com/office/powerpoint/2010/main" val="445109523"/>
                    </p:ext>
                  </p:extLst>
                </p:nvPr>
              </p:nvGraphicFramePr>
              <p:xfrm>
                <a:off x="3518" y="5786656"/>
                <a:ext cx="6746149" cy="2901448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6"/>
                </a:graphicData>
              </a:graphic>
            </p:graphicFrame>
            <p:graphicFrame>
              <p:nvGraphicFramePr>
                <p:cNvPr id="11" name="Chart 10">
                  <a:extLst>
                    <a:ext uri="{FF2B5EF4-FFF2-40B4-BE49-F238E27FC236}">
                      <a16:creationId xmlns:a16="http://schemas.microsoft.com/office/drawing/2014/main" id="{B6C3DF2A-41DA-46C5-861C-2196D0DAEBA1}"/>
                    </a:ext>
                  </a:extLst>
                </p:cNvPr>
                <p:cNvGraphicFramePr>
                  <a:graphicFrameLocks/>
                </p:cNvGraphicFramePr>
                <p:nvPr>
                  <p:extLst>
                    <p:ext uri="{D42A27DB-BD31-4B8C-83A1-F6EECF244321}">
                      <p14:modId xmlns:p14="http://schemas.microsoft.com/office/powerpoint/2010/main" val="1533739449"/>
                    </p:ext>
                  </p:extLst>
                </p:nvPr>
              </p:nvGraphicFramePr>
              <p:xfrm>
                <a:off x="6721520" y="5770518"/>
                <a:ext cx="6746149" cy="2901448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7"/>
                </a:graphicData>
              </a:graphic>
            </p:graphicFrame>
          </p:grpSp>
          <p:sp>
            <p:nvSpPr>
              <p:cNvPr id="12" name="Text Box 16">
                <a:extLst>
                  <a:ext uri="{FF2B5EF4-FFF2-40B4-BE49-F238E27FC236}">
                    <a16:creationId xmlns:a16="http://schemas.microsoft.com/office/drawing/2014/main" id="{F1216812-CDC5-924D-BBE8-440C744CA498}"/>
                  </a:ext>
                </a:extLst>
              </p:cNvPr>
              <p:cNvSpPr txBox="1"/>
              <p:nvPr/>
            </p:nvSpPr>
            <p:spPr>
              <a:xfrm>
                <a:off x="3750368" y="5801684"/>
                <a:ext cx="2068623" cy="267176"/>
              </a:xfrm>
              <a:prstGeom prst="rect">
                <a:avLst/>
              </a:prstGeom>
              <a:solidFill>
                <a:schemeClr val="lt1"/>
              </a:solidFill>
              <a:ln w="6350">
                <a:noFill/>
              </a:ln>
            </p:spPr>
            <p:txBody>
              <a:bodyPr rot="0" spcFirstLastPara="0" vert="horz" wrap="square" lIns="68580" tIns="34290" rIns="68580" bIns="34290" numCol="1" spcCol="0" rtlCol="0" fromWordArt="0" anchor="t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/>
                <a:r>
                  <a:rPr lang="en-US" sz="1400" b="1" dirty="0">
                    <a:latin typeface="Calibri" panose="020F0502020204030204" pitchFamily="34" charset="0"/>
                    <a:ea typeface="Times New Roman" panose="02020603050405020304" pitchFamily="18" charset="0"/>
                    <a:cs typeface="Calibri" panose="020F0502020204030204" pitchFamily="34" charset="0"/>
                  </a:rPr>
                  <a:t>Sample Month and Year</a:t>
                </a:r>
                <a:endParaRPr lang="en-US" sz="1400" dirty="0">
                  <a:latin typeface="Calibri" panose="020F0502020204030204" pitchFamily="34" charset="0"/>
                  <a:ea typeface="Times New Roman" panose="02020603050405020304" pitchFamily="18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13" name="Text Box 18">
                <a:extLst>
                  <a:ext uri="{FF2B5EF4-FFF2-40B4-BE49-F238E27FC236}">
                    <a16:creationId xmlns:a16="http://schemas.microsoft.com/office/drawing/2014/main" id="{79EA0165-6E10-EE45-B919-B8F9EE03916F}"/>
                  </a:ext>
                </a:extLst>
              </p:cNvPr>
              <p:cNvSpPr txBox="1"/>
              <p:nvPr/>
            </p:nvSpPr>
            <p:spPr>
              <a:xfrm rot="10800000">
                <a:off x="292608" y="824548"/>
                <a:ext cx="397827" cy="4695825"/>
              </a:xfrm>
              <a:prstGeom prst="rect">
                <a:avLst/>
              </a:prstGeom>
              <a:solidFill>
                <a:schemeClr val="lt1"/>
              </a:solidFill>
              <a:ln w="6350">
                <a:noFill/>
              </a:ln>
            </p:spPr>
            <p:txBody>
              <a:bodyPr rot="0" spcFirstLastPara="0" vert="eaVert" wrap="square" lIns="68580" tIns="34290" rIns="68580" bIns="34290" numCol="1" spcCol="0" rtlCol="0" fromWordArt="0" anchor="t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/>
                <a:r>
                  <a:rPr lang="en-US" sz="1400" b="1" dirty="0">
                    <a:latin typeface="Calibri" panose="020F0502020204030204" pitchFamily="34" charset="0"/>
                    <a:ea typeface="Times New Roman" panose="02020603050405020304" pitchFamily="18" charset="0"/>
                    <a:cs typeface="Calibri" panose="020F0502020204030204" pitchFamily="34" charset="0"/>
                  </a:rPr>
                  <a:t>Probability of </a:t>
                </a:r>
                <a:r>
                  <a:rPr lang="en-US" sz="1400" b="1" i="1" dirty="0">
                    <a:latin typeface="Calibri" panose="020F0502020204030204" pitchFamily="34" charset="0"/>
                    <a:ea typeface="Times New Roman" panose="02020603050405020304" pitchFamily="18" charset="0"/>
                    <a:cs typeface="Calibri" panose="020F0502020204030204" pitchFamily="34" charset="0"/>
                  </a:rPr>
                  <a:t>A. </a:t>
                </a:r>
                <a:r>
                  <a:rPr lang="en-US" sz="1400" b="1" i="1" dirty="0" err="1">
                    <a:latin typeface="Calibri" panose="020F0502020204030204" pitchFamily="34" charset="0"/>
                    <a:ea typeface="Times New Roman" panose="02020603050405020304" pitchFamily="18" charset="0"/>
                    <a:cs typeface="Calibri" panose="020F0502020204030204" pitchFamily="34" charset="0"/>
                  </a:rPr>
                  <a:t>toschiella</a:t>
                </a:r>
                <a:r>
                  <a:rPr lang="en-US" sz="1400" b="1" dirty="0">
                    <a:latin typeface="Calibri" panose="020F0502020204030204" pitchFamily="34" charset="0"/>
                    <a:ea typeface="Times New Roman" panose="02020603050405020304" pitchFamily="18" charset="0"/>
                    <a:cs typeface="Calibri" panose="020F0502020204030204" pitchFamily="34" charset="0"/>
                  </a:rPr>
                  <a:t> biotype 1 occurrence (mean </a:t>
                </a:r>
                <a:r>
                  <a:rPr lang="en-US" sz="1400" b="1" dirty="0">
                    <a:solidFill>
                      <a:srgbClr val="000000"/>
                    </a:solidFill>
                    <a:latin typeface="Calibri" panose="020F0502020204030204" pitchFamily="34" charset="0"/>
                    <a:ea typeface="Times New Roman" panose="02020603050405020304" pitchFamily="18" charset="0"/>
                    <a:cs typeface="Calibri" panose="020F0502020204030204" pitchFamily="34" charset="0"/>
                  </a:rPr>
                  <a:t>± </a:t>
                </a:r>
                <a:r>
                  <a:rPr lang="en-US" sz="1400" b="1" dirty="0">
                    <a:latin typeface="Calibri" panose="020F0502020204030204" pitchFamily="34" charset="0"/>
                    <a:ea typeface="Times New Roman" panose="02020603050405020304" pitchFamily="18" charset="0"/>
                    <a:cs typeface="Calibri" panose="020F0502020204030204" pitchFamily="34" charset="0"/>
                  </a:rPr>
                  <a:t>SE)</a:t>
                </a:r>
                <a:endParaRPr lang="en-US" sz="1400" dirty="0">
                  <a:latin typeface="Calibri" panose="020F050202020403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4" name="Rectangle 13">
                <a:extLst>
                  <a:ext uri="{FF2B5EF4-FFF2-40B4-BE49-F238E27FC236}">
                    <a16:creationId xmlns:a16="http://schemas.microsoft.com/office/drawing/2014/main" id="{0D0EB759-F897-1F49-80B2-711099EC09E8}"/>
                  </a:ext>
                </a:extLst>
              </p:cNvPr>
              <p:cNvSpPr>
                <a:spLocks noChangeAspect="1"/>
              </p:cNvSpPr>
              <p:nvPr/>
            </p:nvSpPr>
            <p:spPr>
              <a:xfrm>
                <a:off x="1019808" y="738799"/>
                <a:ext cx="300163" cy="260907"/>
              </a:xfrm>
              <a:prstGeom prst="rect">
                <a:avLst/>
              </a:prstGeom>
              <a:solidFill>
                <a:schemeClr val="bg1"/>
              </a:solidFill>
              <a:ln w="2667">
                <a:noFill/>
              </a:ln>
            </p:spPr>
            <p:txBody>
              <a:bodyPr wrap="none">
                <a:noAutofit/>
              </a:bodyPr>
              <a:lstStyle/>
              <a:p>
                <a:pPr algn="ctr"/>
                <a:r>
                  <a:rPr lang="en-US" sz="1200" b="1" dirty="0">
                    <a:solidFill>
                      <a:srgbClr val="000000"/>
                    </a:solidFill>
                    <a:latin typeface="Calibri" panose="020F0502020204030204" pitchFamily="34" charset="0"/>
                    <a:ea typeface="PMingLiU" panose="02020500000000000000" pitchFamily="18" charset="-120"/>
                    <a:cs typeface="Calibri" panose="020F0502020204030204" pitchFamily="34" charset="0"/>
                  </a:rPr>
                  <a:t>A</a:t>
                </a:r>
                <a:endParaRPr lang="en-US" sz="1600" dirty="0">
                  <a:latin typeface="Calibri" panose="020F050202020403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" name="Rectangle 14">
                <a:extLst>
                  <a:ext uri="{FF2B5EF4-FFF2-40B4-BE49-F238E27FC236}">
                    <a16:creationId xmlns:a16="http://schemas.microsoft.com/office/drawing/2014/main" id="{152FFD08-AA0A-5B4B-A2DE-8BED9F2A4059}"/>
                  </a:ext>
                </a:extLst>
              </p:cNvPr>
              <p:cNvSpPr>
                <a:spLocks noChangeAspect="1"/>
              </p:cNvSpPr>
              <p:nvPr/>
            </p:nvSpPr>
            <p:spPr>
              <a:xfrm>
                <a:off x="5066567" y="702352"/>
                <a:ext cx="273692" cy="244391"/>
              </a:xfrm>
              <a:prstGeom prst="rect">
                <a:avLst/>
              </a:prstGeom>
              <a:solidFill>
                <a:schemeClr val="bg1"/>
              </a:solidFill>
              <a:ln w="1270">
                <a:noFill/>
              </a:ln>
            </p:spPr>
            <p:txBody>
              <a:bodyPr wrap="none">
                <a:noAutofit/>
              </a:bodyPr>
              <a:lstStyle/>
              <a:p>
                <a:pPr algn="ctr"/>
                <a:r>
                  <a:rPr lang="en-US" sz="1200" b="1" dirty="0">
                    <a:solidFill>
                      <a:srgbClr val="000000"/>
                    </a:solidFill>
                    <a:latin typeface="Calibri" panose="020F0502020204030204" pitchFamily="34" charset="0"/>
                    <a:ea typeface="PMingLiU" panose="02020500000000000000" pitchFamily="18" charset="-120"/>
                    <a:cs typeface="Calibri" panose="020F0502020204030204" pitchFamily="34" charset="0"/>
                  </a:rPr>
                  <a:t>B</a:t>
                </a:r>
                <a:endParaRPr lang="en-US" sz="1600" dirty="0">
                  <a:latin typeface="Calibri" panose="020F050202020403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6" name="Rectangle 15">
                <a:extLst>
                  <a:ext uri="{FF2B5EF4-FFF2-40B4-BE49-F238E27FC236}">
                    <a16:creationId xmlns:a16="http://schemas.microsoft.com/office/drawing/2014/main" id="{1ABC20D7-760C-5147-A9CA-875154673DF7}"/>
                  </a:ext>
                </a:extLst>
              </p:cNvPr>
              <p:cNvSpPr>
                <a:spLocks noChangeAspect="1"/>
              </p:cNvSpPr>
              <p:nvPr/>
            </p:nvSpPr>
            <p:spPr>
              <a:xfrm>
                <a:off x="1130348" y="2583679"/>
                <a:ext cx="189623" cy="171450"/>
              </a:xfrm>
              <a:prstGeom prst="rect">
                <a:avLst/>
              </a:prstGeom>
              <a:solidFill>
                <a:schemeClr val="bg1"/>
              </a:solidFill>
              <a:ln w="3175">
                <a:noFill/>
              </a:ln>
            </p:spPr>
            <p:txBody>
              <a:bodyPr wrap="none">
                <a:noAutofit/>
              </a:bodyPr>
              <a:lstStyle/>
              <a:p>
                <a:pPr algn="ctr"/>
                <a:r>
                  <a:rPr lang="en-US" sz="1200" b="1" dirty="0">
                    <a:solidFill>
                      <a:srgbClr val="000000"/>
                    </a:solidFill>
                    <a:latin typeface="Calibri" panose="020F0502020204030204" pitchFamily="34" charset="0"/>
                    <a:ea typeface="PMingLiU" panose="02020500000000000000" pitchFamily="18" charset="-120"/>
                    <a:cs typeface="Calibri" panose="020F0502020204030204" pitchFamily="34" charset="0"/>
                  </a:rPr>
                  <a:t>C</a:t>
                </a:r>
                <a:endParaRPr lang="en-US" sz="1600" dirty="0">
                  <a:latin typeface="Calibri" panose="020F050202020403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7" name="Rectangle 16">
                <a:extLst>
                  <a:ext uri="{FF2B5EF4-FFF2-40B4-BE49-F238E27FC236}">
                    <a16:creationId xmlns:a16="http://schemas.microsoft.com/office/drawing/2014/main" id="{3C6CF842-CD73-3B45-9049-94BFA78FC1CC}"/>
                  </a:ext>
                </a:extLst>
              </p:cNvPr>
              <p:cNvSpPr>
                <a:spLocks noChangeAspect="1"/>
              </p:cNvSpPr>
              <p:nvPr/>
            </p:nvSpPr>
            <p:spPr>
              <a:xfrm>
                <a:off x="5087659" y="2583679"/>
                <a:ext cx="189623" cy="171450"/>
              </a:xfrm>
              <a:prstGeom prst="rect">
                <a:avLst/>
              </a:prstGeom>
              <a:solidFill>
                <a:schemeClr val="bg1"/>
              </a:solidFill>
              <a:ln w="3175">
                <a:noFill/>
              </a:ln>
            </p:spPr>
            <p:txBody>
              <a:bodyPr wrap="none">
                <a:noAutofit/>
              </a:bodyPr>
              <a:lstStyle/>
              <a:p>
                <a:pPr algn="ctr"/>
                <a:r>
                  <a:rPr lang="en-US" sz="1200" b="1" dirty="0">
                    <a:solidFill>
                      <a:srgbClr val="000000"/>
                    </a:solidFill>
                    <a:latin typeface="Calibri" panose="020F0502020204030204" pitchFamily="34" charset="0"/>
                    <a:ea typeface="PMingLiU" panose="02020500000000000000" pitchFamily="18" charset="-120"/>
                    <a:cs typeface="Calibri" panose="020F0502020204030204" pitchFamily="34" charset="0"/>
                  </a:rPr>
                  <a:t>D</a:t>
                </a:r>
                <a:endParaRPr lang="en-US" sz="1600" dirty="0">
                  <a:latin typeface="Calibri" panose="020F050202020403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8" name="Rectangle 21">
                <a:extLst>
                  <a:ext uri="{FF2B5EF4-FFF2-40B4-BE49-F238E27FC236}">
                    <a16:creationId xmlns:a16="http://schemas.microsoft.com/office/drawing/2014/main" id="{53114405-B20A-BB44-B786-220D8A82FCE0}"/>
                  </a:ext>
                </a:extLst>
              </p:cNvPr>
              <p:cNvSpPr>
                <a:spLocks noChangeAspect="1"/>
              </p:cNvSpPr>
              <p:nvPr/>
            </p:nvSpPr>
            <p:spPr bwMode="auto">
              <a:xfrm>
                <a:off x="1224451" y="4304794"/>
                <a:ext cx="185812" cy="171450"/>
              </a:xfrm>
              <a:prstGeom prst="rect">
                <a:avLst/>
              </a:prstGeom>
              <a:solidFill>
                <a:srgbClr val="FFFFFF"/>
              </a:solidFill>
              <a:ln w="3175">
                <a:noFill/>
                <a:miter lim="800000"/>
                <a:headEnd/>
                <a:tailEnd/>
              </a:ln>
            </p:spPr>
            <p:txBody>
              <a:bodyPr vert="horz" wrap="none" lIns="68580" tIns="34290" rIns="68580" bIns="34290" numCol="1" anchor="t" anchorCtr="0" compatLnSpc="1">
                <a:prstTxWarp prst="textNoShape">
                  <a:avLst/>
                </a:prstTxWarp>
              </a:bodyPr>
              <a:lstStyle/>
              <a:p>
                <a:pPr algn="ctr" defTabSz="685784" eaLnBrk="0" fontAlgn="base" hangingPunct="0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US" altLang="en-US" sz="1200" b="1" dirty="0">
                    <a:solidFill>
                      <a:srgbClr val="000000"/>
                    </a:solidFill>
                    <a:latin typeface="Calibri" panose="020F0502020204030204" pitchFamily="34" charset="0"/>
                    <a:ea typeface="PMingLiU" panose="02020500000000000000" pitchFamily="18" charset="-120"/>
                    <a:cs typeface="Calibri" panose="020F0502020204030204" pitchFamily="34" charset="0"/>
                  </a:rPr>
                  <a:t>E</a:t>
                </a:r>
                <a:endParaRPr lang="en-US" altLang="en-US" sz="1200" dirty="0">
                  <a:latin typeface="Arial" panose="020B0604020202020204" pitchFamily="34" charset="0"/>
                </a:endParaRPr>
              </a:p>
            </p:txBody>
          </p:sp>
          <p:sp>
            <p:nvSpPr>
              <p:cNvPr id="19" name="Rectangle 18">
                <a:extLst>
                  <a:ext uri="{FF2B5EF4-FFF2-40B4-BE49-F238E27FC236}">
                    <a16:creationId xmlns:a16="http://schemas.microsoft.com/office/drawing/2014/main" id="{7BD425BC-63A8-754E-A643-D4A4F0E04849}"/>
                  </a:ext>
                </a:extLst>
              </p:cNvPr>
              <p:cNvSpPr>
                <a:spLocks noChangeAspect="1"/>
              </p:cNvSpPr>
              <p:nvPr/>
            </p:nvSpPr>
            <p:spPr>
              <a:xfrm>
                <a:off x="5087659" y="4267138"/>
                <a:ext cx="182953" cy="171450"/>
              </a:xfrm>
              <a:prstGeom prst="rect">
                <a:avLst/>
              </a:prstGeom>
              <a:solidFill>
                <a:schemeClr val="bg1"/>
              </a:solidFill>
              <a:ln w="3175">
                <a:noFill/>
              </a:ln>
            </p:spPr>
            <p:txBody>
              <a:bodyPr wrap="none">
                <a:noAutofit/>
              </a:bodyPr>
              <a:lstStyle/>
              <a:p>
                <a:pPr algn="ctr"/>
                <a:r>
                  <a:rPr lang="en-US" sz="1200" b="1" dirty="0">
                    <a:solidFill>
                      <a:srgbClr val="000000"/>
                    </a:solidFill>
                    <a:latin typeface="Calibri" panose="020F0502020204030204" pitchFamily="34" charset="0"/>
                    <a:ea typeface="PMingLiU" panose="02020500000000000000" pitchFamily="18" charset="-120"/>
                    <a:cs typeface="Calibri" panose="020F0502020204030204" pitchFamily="34" charset="0"/>
                  </a:rPr>
                  <a:t>F</a:t>
                </a:r>
                <a:endParaRPr lang="en-US" sz="1200" dirty="0">
                  <a:latin typeface="Calibri" panose="020F050202020403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272713942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53</TotalTime>
  <Words>84</Words>
  <Application>Microsoft Macintosh PowerPoint</Application>
  <PresentationFormat>On-screen Show (4:3)</PresentationFormat>
  <Paragraphs>1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 Smith</dc:creator>
  <cp:lastModifiedBy>Microsoft Office User</cp:lastModifiedBy>
  <cp:revision>12</cp:revision>
  <dcterms:created xsi:type="dcterms:W3CDTF">2019-11-04T20:20:12Z</dcterms:created>
  <dcterms:modified xsi:type="dcterms:W3CDTF">2020-04-10T15:44:42Z</dcterms:modified>
</cp:coreProperties>
</file>